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447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793" userDrawn="1">
          <p15:clr>
            <a:srgbClr val="A4A3A4"/>
          </p15:clr>
        </p15:guide>
        <p15:guide id="3" orient="horz" pos="469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55A11"/>
    <a:srgbClr val="3003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4517" autoAdjust="0"/>
    <p:restoredTop sz="95320" autoAdjust="0"/>
  </p:normalViewPr>
  <p:slideViewPr>
    <p:cSldViewPr snapToGrid="0" showGuides="1">
      <p:cViewPr varScale="1">
        <p:scale>
          <a:sx n="82" d="100"/>
          <a:sy n="82" d="100"/>
        </p:scale>
        <p:origin x="1901" y="77"/>
      </p:cViewPr>
      <p:guideLst>
        <p:guide pos="3793"/>
        <p:guide orient="horz" pos="469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4FF141-4FEF-4333-B11C-584026D8E905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AE835B-F104-4314-81BB-D3026DB4889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117005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8A00CD-9A91-4D8E-B2BC-4F2F51EAF694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1E9546-9BC9-43B9-B151-2C08AC049B1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293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507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7996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5425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6414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9127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871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4335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3121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9112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2123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2634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79A9A-B17B-486E-9AB8-243E554DCD13}" type="datetimeFigureOut">
              <a:rPr lang="ko-KR" altLang="en-US" smtClean="0"/>
              <a:t>2021-05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9E506B-6C32-4A48-A38F-4D01FB7D80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61601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777068" y="8775400"/>
            <a:ext cx="1119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2 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1" y="133350"/>
            <a:ext cx="416329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b="1" dirty="0"/>
              <a:t>Pathway-focused </a:t>
            </a:r>
            <a:r>
              <a:rPr lang="en-US" altLang="ko-KR" sz="1100" b="1" dirty="0" err="1"/>
              <a:t>miScript</a:t>
            </a:r>
            <a:r>
              <a:rPr lang="en-US" altLang="ko-KR" sz="1100" b="1" dirty="0"/>
              <a:t> miRNA PCR Arrays (Tumor suppressor)</a:t>
            </a:r>
            <a:endParaRPr lang="ko-KR" altLang="en-US" sz="1100" dirty="0"/>
          </a:p>
        </p:txBody>
      </p:sp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3186124"/>
              </p:ext>
            </p:extLst>
          </p:nvPr>
        </p:nvGraphicFramePr>
        <p:xfrm>
          <a:off x="53439" y="671277"/>
          <a:ext cx="6751128" cy="7950762"/>
        </p:xfrm>
        <a:graphic>
          <a:graphicData uri="http://schemas.openxmlformats.org/drawingml/2006/table">
            <a:tbl>
              <a:tblPr/>
              <a:tblGrid>
                <a:gridCol w="94097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2885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885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2885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2885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25016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92431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9243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92431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92431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22597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NA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V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-V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DKC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-DKC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NA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V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-V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DKC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K-DKC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el-miR-39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±0.54)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4(±0.5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4(±0.2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4(±0.0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15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let-7a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1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4(±2.2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1(±0.3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5(±0.2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16b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let-7b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3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0(±0.6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2(±0.5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8(±0.2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18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1.5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55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.2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let-7c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2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85(±3.3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7(±0.2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11(±0.6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2-3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6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let-7d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2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4(±0.1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5(±0.1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5(±0.0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23-3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1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let-7e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1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2(±0.2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0(±0.0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1(±0.0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3b-3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let-7f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1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18(±0.3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5(±0.2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44(±0.8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4-3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9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let-7g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3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5(±0.1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3(±0.3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30(±0.2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5-3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2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2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8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let-7i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3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7(±0.0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3(±0.1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8(±0.0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6a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1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6(±0.5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1(±0.4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4(±0.3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6b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1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00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2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5(±0.1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5(±0.5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5(±0.3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96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5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0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01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5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6(±1.1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3(±0.1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1(±0.5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9a-3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22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1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7(±0.2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07(±0.6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8(±0.2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9b-3p,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1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1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4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24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2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5(±0.0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4(±0.2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59(±0.3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9c-3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25a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1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6(±0.2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9(±0.2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8(±0.2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30a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0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25b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2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6(±0.2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7(±0.4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1(±0.3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30c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3.3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26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2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9(±0.2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6(±0.2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2(±0.3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335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9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28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5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2(±0.3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39(±0.6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4(±1.0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34a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0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291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8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8(±1.1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8(±0.0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0(±0.0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34b-3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33a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3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6(±0.3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4(±0.2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1(±0.4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34c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33b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5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6(±0.1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4(±0.1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1(±0.0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370-3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9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6.4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488.8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60.2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30.6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48.9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37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2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4(±1.1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32(±0.3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8(±0.2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372-3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0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9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3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38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1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6(±0.4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1(±0.2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6(±0.0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424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.8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3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.4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40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2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1(±0.7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1(±0.3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1(±0.2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449a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41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0(±0.8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3(±0.5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8(±0.7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2(±0.8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483-3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0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9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42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483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43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486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45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3.3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497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46a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502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5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50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517b-3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52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96(17.11)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304.1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8194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2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520f-3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1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4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.1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55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9)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542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2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2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5a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0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622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1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1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3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6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96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2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1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5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81a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2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98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81b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1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9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99a-5p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6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2)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85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7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.elegance miR-39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2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9.4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6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4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1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92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6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6)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.eleganc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miR-39</a:t>
                      </a:r>
                    </a:p>
                  </a:txBody>
                  <a:tcPr marL="7326" marR="7326" marT="732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5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4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1.6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4.1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1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8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93a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.0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3.2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3.7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RD6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7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4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4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0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93b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RD68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9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3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8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7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95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9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8)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1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RD7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5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00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5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9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601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196b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RD9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9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6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7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1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667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00a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9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ORD96A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69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9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.43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ko-KR" sz="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.40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1667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00b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8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U6B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2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5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2412135"/>
                  </a:ext>
                </a:extLst>
              </a:tr>
              <a:tr h="1667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00c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34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5.1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8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TC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7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7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7280706"/>
                  </a:ext>
                </a:extLst>
              </a:tr>
              <a:tr h="1667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06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5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8)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TC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5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5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3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3597551"/>
                  </a:ext>
                </a:extLst>
              </a:tr>
              <a:tr h="1667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11-5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4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73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06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C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9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5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8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6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6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.70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7118822"/>
                  </a:ext>
                </a:extLst>
              </a:tr>
              <a:tr h="1667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sa-miR-214-3p</a:t>
                      </a: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3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9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07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2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21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64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C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4083" marR="4083" marT="4083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0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72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0.15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3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1.38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1(</a:t>
                      </a:r>
                      <a:r>
                        <a:rPr lang="en-US" altLang="ko-K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2.79)</a:t>
                      </a:r>
                      <a:endParaRPr lang="en-US" altLang="ko-KR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7326" marR="7326" marT="732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706139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693371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175</TotalTime>
  <Words>1655</Words>
  <Application>Microsoft Office PowerPoint</Application>
  <PresentationFormat>화면 슬라이드 쇼(4:3)</PresentationFormat>
  <Paragraphs>49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배정아</dc:creator>
  <cp:lastModifiedBy>user</cp:lastModifiedBy>
  <cp:revision>821</cp:revision>
  <cp:lastPrinted>2020-12-14T02:52:41Z</cp:lastPrinted>
  <dcterms:created xsi:type="dcterms:W3CDTF">2017-02-20T02:17:55Z</dcterms:created>
  <dcterms:modified xsi:type="dcterms:W3CDTF">2021-05-12T02:51:56Z</dcterms:modified>
</cp:coreProperties>
</file>